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032A8-C237-4DF9-957A-9E8EB616EE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9985AE-E5B0-4E96-9EB2-E47946E0E31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7477AC-51B3-40A7-8A0C-FB6189CC363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AF10F-EBA3-4410-BE51-D6F02C5AD9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31F968-B316-434F-B3C4-1E9305E9FC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FCC6A-B3B6-41B6-8D73-AEDE12E46A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F9DF86-E940-4816-A672-C1CA58E8A7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248BE-08DD-49DD-836E-9FB2B2EE3F2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B3CC08-5BA6-4B0D-B929-C90970B53A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C617F6-887F-49B8-A354-239BD88C4B2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040C9F-65B1-4AB6-9217-190F73B7E6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097716-82D1-4AAD-9997-39F7B4FA1F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4D31CC-862A-42E7-A7E6-BBEAE90CCC16}" type="slidenum">
              <a:rPr b="0" lang="he-I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C:\Users\selest\Downloads\Figure S1 (1).TIF"/>
          <p:cNvPicPr/>
          <p:nvPr/>
        </p:nvPicPr>
        <p:blipFill>
          <a:blip r:embed="rId1"/>
          <a:stretch/>
        </p:blipFill>
        <p:spPr>
          <a:xfrm>
            <a:off x="1143000" y="785880"/>
            <a:ext cx="7004160" cy="352728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4"/>
          <p:cNvSpPr/>
          <p:nvPr/>
        </p:nvSpPr>
        <p:spPr>
          <a:xfrm>
            <a:off x="1119240" y="4374360"/>
            <a:ext cx="692928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: Sequence alignment of full-length cpn20 protein from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. thaliana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. falciparum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carried out using ClustalW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range signifies the putative transit peptides, green the linker region, blue the mobile loops and lavender the roof loops. Identical amino acids are marked with a star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conserved amino acids with a colon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, and semi-conserved amino acids with a period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22T14:38:31Z</dcterms:created>
  <dc:creator>selest</dc:creator>
  <dc:description/>
  <dc:language>en-US</dc:language>
  <cp:lastModifiedBy>selest</cp:lastModifiedBy>
  <dcterms:modified xsi:type="dcterms:W3CDTF">2012-11-22T19:33:16Z</dcterms:modified>
  <cp:revision>3</cp:revision>
  <dc:subject/>
  <dc:title>שקופית 1</dc:title>
</cp:coreProperties>
</file>